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4B15164-4652-477A-AD1B-393B3828E7D4}" v="1" dt="2025-08-13T11:53:40.4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34"/>
    <p:restoredTop sz="94658"/>
  </p:normalViewPr>
  <p:slideViewPr>
    <p:cSldViewPr snapToGrid="0">
      <p:cViewPr varScale="1">
        <p:scale>
          <a:sx n="41" d="100"/>
          <a:sy n="41" d="100"/>
        </p:scale>
        <p:origin x="226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99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871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75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964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057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483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14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419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5590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490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522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C87165-C3A4-6849-A03A-43F1337C9274}" type="datetimeFigureOut">
              <a:rPr lang="en-US" smtClean="0"/>
              <a:t>11/1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609900-FFAE-2A46-A629-551B99CE79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680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3">
            <a:extLst>
              <a:ext uri="{FF2B5EF4-FFF2-40B4-BE49-F238E27FC236}">
                <a16:creationId xmlns:a16="http://schemas.microsoft.com/office/drawing/2014/main" id="{6C6D50E2-D4DC-6599-8DC8-6907EF7B3E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l="4637" r="17881" b="4949"/>
          <a:stretch>
            <a:fillRect/>
          </a:stretch>
        </p:blipFill>
        <p:spPr>
          <a:xfrm>
            <a:off x="515461" y="243355"/>
            <a:ext cx="2601365" cy="1929576"/>
          </a:xfrm>
          <a:prstGeom prst="rect">
            <a:avLst/>
          </a:prstGeom>
        </p:spPr>
      </p:pic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6902AAF-2F3B-AD23-BB29-CB32FB44637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3067634" y="248630"/>
            <a:ext cx="2944741" cy="20572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C4FD654-520F-058E-A320-069B1B6F36E9}"/>
              </a:ext>
            </a:extLst>
          </p:cNvPr>
          <p:cNvSpPr txBox="1"/>
          <p:nvPr/>
        </p:nvSpPr>
        <p:spPr>
          <a:xfrm>
            <a:off x="1160034" y="2178637"/>
            <a:ext cx="111851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G content (%)</a:t>
            </a:r>
            <a:endParaRPr lang="en-AU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D754C83-0E81-7E5F-C10A-65A1C787A23D}"/>
              </a:ext>
            </a:extLst>
          </p:cNvPr>
          <p:cNvSpPr txBox="1"/>
          <p:nvPr/>
        </p:nvSpPr>
        <p:spPr>
          <a:xfrm>
            <a:off x="3840321" y="2228167"/>
            <a:ext cx="1118511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G content (%)</a:t>
            </a:r>
            <a:endParaRPr lang="en-AU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1768BFC-2259-A963-7A93-5840B31E2848}"/>
              </a:ext>
            </a:extLst>
          </p:cNvPr>
          <p:cNvSpPr txBox="1"/>
          <p:nvPr/>
        </p:nvSpPr>
        <p:spPr>
          <a:xfrm>
            <a:off x="106800" y="456899"/>
            <a:ext cx="369332" cy="1476751"/>
          </a:xfrm>
          <a:prstGeom prst="rect">
            <a:avLst/>
          </a:prstGeom>
          <a:solidFill>
            <a:schemeClr val="bg1"/>
          </a:solidFill>
        </p:spPr>
        <p:txBody>
          <a:bodyPr vert="vert270" wrap="none" rtlCol="0">
            <a:spAutoFit/>
          </a:bodyPr>
          <a:lstStyle/>
          <a:p>
            <a:r>
              <a:rPr lang="en-US" sz="1200" dirty="0"/>
              <a:t>Proportion of genome</a:t>
            </a:r>
            <a:endParaRPr lang="en-AU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85CCCEB-F575-22BF-33FD-5A7D6B224830}"/>
              </a:ext>
            </a:extLst>
          </p:cNvPr>
          <p:cNvSpPr txBox="1"/>
          <p:nvPr/>
        </p:nvSpPr>
        <p:spPr>
          <a:xfrm>
            <a:off x="733109" y="1253837"/>
            <a:ext cx="903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7.1%</a:t>
            </a:r>
            <a:endParaRPr lang="en-AU" sz="1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A41882-848B-75F5-30EB-72F2BB29E9ED}"/>
              </a:ext>
            </a:extLst>
          </p:cNvPr>
          <p:cNvSpPr txBox="1"/>
          <p:nvPr/>
        </p:nvSpPr>
        <p:spPr>
          <a:xfrm>
            <a:off x="2191927" y="1253838"/>
            <a:ext cx="6062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72.9%</a:t>
            </a:r>
            <a:endParaRPr lang="en-AU" sz="12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72F526C-8129-2A9D-8EA9-D86127117FE5}"/>
              </a:ext>
            </a:extLst>
          </p:cNvPr>
          <p:cNvSpPr txBox="1"/>
          <p:nvPr/>
        </p:nvSpPr>
        <p:spPr>
          <a:xfrm>
            <a:off x="3524766" y="1253838"/>
            <a:ext cx="6062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21.3%</a:t>
            </a:r>
            <a:endParaRPr lang="en-AU" sz="12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B319071-19AC-67F3-87D4-1E8E53C3B895}"/>
              </a:ext>
            </a:extLst>
          </p:cNvPr>
          <p:cNvSpPr txBox="1"/>
          <p:nvPr/>
        </p:nvSpPr>
        <p:spPr>
          <a:xfrm>
            <a:off x="4951256" y="1253837"/>
            <a:ext cx="646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78.7%</a:t>
            </a:r>
            <a:endParaRPr lang="en-AU" sz="12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7CA759-3A75-30B0-9059-72D6B5187D3A}"/>
              </a:ext>
            </a:extLst>
          </p:cNvPr>
          <p:cNvSpPr txBox="1"/>
          <p:nvPr/>
        </p:nvSpPr>
        <p:spPr>
          <a:xfrm>
            <a:off x="538068" y="20044"/>
            <a:ext cx="22687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i="1" dirty="0"/>
              <a:t>Ampelomyces </a:t>
            </a:r>
            <a:r>
              <a:rPr lang="en-US" sz="1200" b="1" dirty="0"/>
              <a:t>sp</a:t>
            </a:r>
            <a:r>
              <a:rPr lang="en-US" sz="1200" b="1" i="1" dirty="0"/>
              <a:t>.</a:t>
            </a:r>
            <a:r>
              <a:rPr lang="en-US" sz="1200" b="1" dirty="0"/>
              <a:t> BRIP 72102</a:t>
            </a:r>
            <a:endParaRPr lang="en-AU" sz="12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582F5F-E718-DE8A-0260-2E896587D310}"/>
              </a:ext>
            </a:extLst>
          </p:cNvPr>
          <p:cNvSpPr txBox="1"/>
          <p:nvPr/>
        </p:nvSpPr>
        <p:spPr>
          <a:xfrm>
            <a:off x="3244495" y="29875"/>
            <a:ext cx="22687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 </a:t>
            </a:r>
            <a:r>
              <a:rPr lang="en-US" sz="1200" b="1" i="1" dirty="0"/>
              <a:t>Ampelomyces </a:t>
            </a:r>
            <a:r>
              <a:rPr lang="en-US" sz="1200" b="1" dirty="0"/>
              <a:t>sp. BRIP 72097</a:t>
            </a:r>
            <a:endParaRPr lang="en-AU" sz="12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774CCDD-7344-C373-1ECF-1F752B5885E0}"/>
              </a:ext>
            </a:extLst>
          </p:cNvPr>
          <p:cNvSpPr txBox="1"/>
          <p:nvPr/>
        </p:nvSpPr>
        <p:spPr>
          <a:xfrm>
            <a:off x="106800" y="3003245"/>
            <a:ext cx="65988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/>
              <a:t>Suppl</a:t>
            </a:r>
            <a:r>
              <a:rPr lang="en-AU" b="1" dirty="0"/>
              <a:t>. Fig. 3. The GC content distribution of genome assemblies of </a:t>
            </a:r>
            <a:r>
              <a:rPr lang="en-AU" b="1" i="1" dirty="0"/>
              <a:t>Ampelomyces</a:t>
            </a:r>
            <a:r>
              <a:rPr lang="en-AU" b="1" dirty="0"/>
              <a:t> strains BRIP 72097 and BRIP 72102.</a:t>
            </a:r>
            <a:r>
              <a:rPr lang="en-AU" dirty="0"/>
              <a:t> Vertical blue lines indicate the GC cut-off points selected by </a:t>
            </a:r>
            <a:r>
              <a:rPr lang="en-AU" dirty="0" err="1"/>
              <a:t>OcculterCut</a:t>
            </a:r>
            <a:r>
              <a:rPr lang="en-AU" dirty="0"/>
              <a:t> (43) to classify genome segments into distinct AT-rich and GC-balanced regions. The percent values on the left and right sides of the graphs indicate the percentage of the genome classified as AT-rich and GC-balanced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20516591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b4fff8a3-050f-428f-b966-cc56f581f9b1}" enabled="1" method="Standard" siteId="{7dfbfb93-19b6-4985-ac7e-501a37938456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</TotalTime>
  <Words>102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loofar Vaghefi</dc:creator>
  <cp:lastModifiedBy>Levente Kiss</cp:lastModifiedBy>
  <cp:revision>5</cp:revision>
  <dcterms:created xsi:type="dcterms:W3CDTF">2025-08-12T08:39:43Z</dcterms:created>
  <dcterms:modified xsi:type="dcterms:W3CDTF">2025-11-18T07:57:00Z</dcterms:modified>
</cp:coreProperties>
</file>